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6" r:id="rId4"/>
  </p:sldIdLst>
  <p:sldSz cx="12192000" cy="6858000"/>
  <p:notesSz cx="6858000" cy="9144000"/>
  <p:defaultTextStyle>
    <a:defPPr>
      <a:defRPr lang="en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6405"/>
  </p:normalViewPr>
  <p:slideViewPr>
    <p:cSldViewPr snapToGrid="0">
      <p:cViewPr varScale="1">
        <p:scale>
          <a:sx n="127" d="100"/>
          <a:sy n="127" d="100"/>
        </p:scale>
        <p:origin x="44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edretti Silvia" userId="71862236-c2a8-4438-b1bc-c3b92550602c" providerId="ADAL" clId="{9493F0C7-D205-564F-966D-4289FB3ADAF9}"/>
    <pc:docChg chg="modSld">
      <pc:chgData name="Pedretti Silvia" userId="71862236-c2a8-4438-b1bc-c3b92550602c" providerId="ADAL" clId="{9493F0C7-D205-564F-966D-4289FB3ADAF9}" dt="2025-05-19T11:44:35.176" v="6" actId="790"/>
      <pc:docMkLst>
        <pc:docMk/>
      </pc:docMkLst>
      <pc:sldChg chg="modSp mod">
        <pc:chgData name="Pedretti Silvia" userId="71862236-c2a8-4438-b1bc-c3b92550602c" providerId="ADAL" clId="{9493F0C7-D205-564F-966D-4289FB3ADAF9}" dt="2025-05-19T11:44:35.176" v="6" actId="790"/>
        <pc:sldMkLst>
          <pc:docMk/>
          <pc:sldMk cId="699004552" sldId="256"/>
        </pc:sldMkLst>
        <pc:spChg chg="mod">
          <ac:chgData name="Pedretti Silvia" userId="71862236-c2a8-4438-b1bc-c3b92550602c" providerId="ADAL" clId="{9493F0C7-D205-564F-966D-4289FB3ADAF9}" dt="2025-05-19T11:44:35.176" v="6" actId="790"/>
          <ac:spMkLst>
            <pc:docMk/>
            <pc:sldMk cId="699004552" sldId="256"/>
            <ac:spMk id="4" creationId="{803F46DD-E52C-CBE5-7452-FBA9151A7076}"/>
          </ac:spMkLst>
        </pc:spChg>
      </pc:sldChg>
      <pc:sldChg chg="modSp mod">
        <pc:chgData name="Pedretti Silvia" userId="71862236-c2a8-4438-b1bc-c3b92550602c" providerId="ADAL" clId="{9493F0C7-D205-564F-966D-4289FB3ADAF9}" dt="2025-05-16T07:33:36.346" v="1" actId="20577"/>
        <pc:sldMkLst>
          <pc:docMk/>
          <pc:sldMk cId="1792299941" sldId="257"/>
        </pc:sldMkLst>
        <pc:spChg chg="mod">
          <ac:chgData name="Pedretti Silvia" userId="71862236-c2a8-4438-b1bc-c3b92550602c" providerId="ADAL" clId="{9493F0C7-D205-564F-966D-4289FB3ADAF9}" dt="2025-05-16T07:33:36.346" v="1" actId="20577"/>
          <ac:spMkLst>
            <pc:docMk/>
            <pc:sldMk cId="1792299941" sldId="257"/>
            <ac:spMk id="2" creationId="{39064B17-17E3-D13E-CAC1-1552FF7582A4}"/>
          </ac:spMkLst>
        </pc:spChg>
      </pc:sldChg>
      <pc:sldChg chg="modSp mod">
        <pc:chgData name="Pedretti Silvia" userId="71862236-c2a8-4438-b1bc-c3b92550602c" providerId="ADAL" clId="{9493F0C7-D205-564F-966D-4289FB3ADAF9}" dt="2025-05-19T11:43:54.446" v="5" actId="20577"/>
        <pc:sldMkLst>
          <pc:docMk/>
          <pc:sldMk cId="2998316817" sldId="258"/>
        </pc:sldMkLst>
        <pc:spChg chg="mod">
          <ac:chgData name="Pedretti Silvia" userId="71862236-c2a8-4438-b1bc-c3b92550602c" providerId="ADAL" clId="{9493F0C7-D205-564F-966D-4289FB3ADAF9}" dt="2025-05-19T11:43:54.446" v="5" actId="20577"/>
          <ac:spMkLst>
            <pc:docMk/>
            <pc:sldMk cId="2998316817" sldId="258"/>
            <ac:spMk id="2" creationId="{39064B17-17E3-D13E-CAC1-1552FF7582A4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CD13B3-7B7D-106B-E698-E62E7B66320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B5FE913-D81A-F099-D95D-DC55F0B37E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9C2288-C3ED-0186-82B9-D73942D4EF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793E7-87EA-424A-8641-783830242285}" type="datetimeFigureOut">
              <a:rPr lang="en-US" smtClean="0"/>
              <a:t>5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99C3A4-F8F6-DB12-579F-4EAEF9C0B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4005F7-5AC9-7550-3683-D8EC101535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4294D-AB14-2B40-82C8-AD855504B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243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1A003A-776F-060C-D24D-BA3CA97A71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915B09-EE8C-E9F1-8960-F2395D3194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F42FEE-9C29-34F0-8129-EC306355F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793E7-87EA-424A-8641-783830242285}" type="datetimeFigureOut">
              <a:rPr lang="en-US" smtClean="0"/>
              <a:t>5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0DA3C8-555C-1502-2086-C46DEE5781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095433-0E6E-FF93-06E3-555815889D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4294D-AB14-2B40-82C8-AD855504B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4684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D3E2352-06A0-B4AF-58BC-A0D7C005B1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93E286-5FD2-7C66-63E0-826334D21B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1361AE-7804-F45E-7E0D-DBFE7D2D1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793E7-87EA-424A-8641-783830242285}" type="datetimeFigureOut">
              <a:rPr lang="en-US" smtClean="0"/>
              <a:t>5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767154-67D8-662C-975F-4D1C96B33B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9CCD44-2577-A8B3-FD88-E99C6F6AD2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4294D-AB14-2B40-82C8-AD855504B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411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7D0027-576B-8107-1A05-810BCA0076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3B1913-7250-694C-394F-F9286EF6532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2BB7CE-AE9D-01C1-36C1-69153AF28D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793E7-87EA-424A-8641-783830242285}" type="datetimeFigureOut">
              <a:rPr lang="en-US" smtClean="0"/>
              <a:t>5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051B9C-DE1B-3166-3851-4244CB12E5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D0F650-A65A-22C4-8B75-4363C41768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4294D-AB14-2B40-82C8-AD855504B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397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4F860A-D2FE-2E69-76BD-569EBD6D63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06E856-ACE4-0DDA-1767-4BB7BBA12E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093CC4-62B6-03FF-8CC0-3BCF0CB3DB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793E7-87EA-424A-8641-783830242285}" type="datetimeFigureOut">
              <a:rPr lang="en-US" smtClean="0"/>
              <a:t>5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932736-7ECC-B62D-17FA-6ED0960FD1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CC12D7-85EC-A48D-8533-333AB65019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4294D-AB14-2B40-82C8-AD855504B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565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C31DFF-7AA1-21F4-F1C1-59A77CE68D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73EE81-BE62-9CDD-D644-B625CD3506C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6C7BBB-E26B-FA70-CB2C-385D8FB4DE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68055A-9AF5-FC65-BF5C-76C37E73A6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793E7-87EA-424A-8641-783830242285}" type="datetimeFigureOut">
              <a:rPr lang="en-US" smtClean="0"/>
              <a:t>5/1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0E2E7F-F60B-B2AE-E684-86878A49E2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12F1C1-A9CA-128E-89E2-9D744B96D8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4294D-AB14-2B40-82C8-AD855504B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65746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5F3AFE-8FA4-0300-F0C3-368E5382BC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CDD78E-DABF-3820-2E31-793A7A417D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5E8840-C1C0-83B4-A47A-BA3556B012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4BF3948-505D-D85F-8EE8-A6738E7F6B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81B2703-9D6E-3CE0-D3EE-85907047A2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90A293B-F1F3-01EA-4CFF-C2C5030A7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793E7-87EA-424A-8641-783830242285}" type="datetimeFigureOut">
              <a:rPr lang="en-US" smtClean="0"/>
              <a:t>5/19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8E84EE4-4A3A-ABC0-0060-C44315C9E0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1D0E245-8027-F26A-2304-A07E44FFF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4294D-AB14-2B40-82C8-AD855504B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8646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6047B5-BAB2-26FB-0769-A6BCFF5F3C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9BA4797-B9A8-96C3-AF61-54A5D57F25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793E7-87EA-424A-8641-783830242285}" type="datetimeFigureOut">
              <a:rPr lang="en-US" smtClean="0"/>
              <a:t>5/19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56127DE-4346-DED7-AAAD-A1DCF6D874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173B2DE-0E5C-4E14-505E-D04D4529E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4294D-AB14-2B40-82C8-AD855504B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055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CEE0631-0978-B792-87CD-C984A96315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793E7-87EA-424A-8641-783830242285}" type="datetimeFigureOut">
              <a:rPr lang="en-US" smtClean="0"/>
              <a:t>5/19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0985790-8C6E-60E5-0F3B-B6E54A569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855ED2-9E4D-9694-CBFC-5EFDA13D0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4294D-AB14-2B40-82C8-AD855504B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15237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88F0F4-36AE-7EA4-C6DA-AC1774FE1D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D57B5A-F2E2-EC6F-CADA-C845A91579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AA3299-739E-D97D-5E9C-EBA0D03F84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5EEFC2-A328-30B5-100A-2DFBAC0860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793E7-87EA-424A-8641-783830242285}" type="datetimeFigureOut">
              <a:rPr lang="en-US" smtClean="0"/>
              <a:t>5/1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317D88-8415-DCD7-4D09-C70EDDE91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7F7B54-50BB-73FA-03D4-EA4CE06143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4294D-AB14-2B40-82C8-AD855504B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250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350FDA-26A7-2D72-E7F5-304C034875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EB76B66-6BE5-4F70-957C-9896E8B1F9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E2733C-EB05-0E8E-36AC-37637829ED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43F7B3-67E4-FA67-5DFA-4A00891339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793E7-87EA-424A-8641-783830242285}" type="datetimeFigureOut">
              <a:rPr lang="en-US" smtClean="0"/>
              <a:t>5/1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D1A085-5B8E-1ED3-BF11-05F774E84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F643C4-9885-0D08-8B74-21C9BA510D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4294D-AB14-2B40-82C8-AD855504B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380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FAE1C08-06BA-42D3-4A77-6DD0159F2F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F91707-8037-A583-488E-8AE6CB5F31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925F77-F1AB-C345-EA6F-5385D01259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E793E7-87EA-424A-8641-783830242285}" type="datetimeFigureOut">
              <a:rPr lang="en-US" smtClean="0"/>
              <a:t>5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933E34-0A56-EB84-2A4E-8B87928F82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895C43-AF64-3931-64FE-CFC6C84256D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B4294D-AB14-2B40-82C8-AD855504B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11198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9064B17-17E3-D13E-CAC1-1552FF7582A4}"/>
              </a:ext>
            </a:extLst>
          </p:cNvPr>
          <p:cNvSpPr txBox="1"/>
          <p:nvPr/>
        </p:nvSpPr>
        <p:spPr>
          <a:xfrm>
            <a:off x="0" y="0"/>
            <a:ext cx="83601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 Gating Strategy for JC-1 - Mitochondrial Membrane Potential Assay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C67CBB6-778D-F717-209C-08A1D824495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111" t="12305" r="12193" b="17481"/>
          <a:stretch/>
        </p:blipFill>
        <p:spPr>
          <a:xfrm>
            <a:off x="675860" y="742121"/>
            <a:ext cx="8507897" cy="55039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22999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9064B17-17E3-D13E-CAC1-1552FF7582A4}"/>
              </a:ext>
            </a:extLst>
          </p:cNvPr>
          <p:cNvSpPr txBox="1"/>
          <p:nvPr/>
        </p:nvSpPr>
        <p:spPr>
          <a:xfrm>
            <a:off x="0" y="0"/>
            <a:ext cx="109233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 Gating Strategy for Detection of Total (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CM-H₂DCFDA) </a:t>
            </a: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nd Mitochondrial ROS (</a:t>
            </a:r>
            <a:r>
              <a:rPr lang="en-GB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MitoSOX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5D1133F-60B8-BC35-E37B-D70ED103951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753" t="12567" r="14511" b="19320"/>
          <a:stretch/>
        </p:blipFill>
        <p:spPr>
          <a:xfrm>
            <a:off x="1258957" y="819091"/>
            <a:ext cx="8203096" cy="50146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83168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03F46DD-E52C-CBE5-7452-FBA9151A7076}"/>
              </a:ext>
            </a:extLst>
          </p:cNvPr>
          <p:cNvSpPr txBox="1"/>
          <p:nvPr/>
        </p:nvSpPr>
        <p:spPr>
          <a:xfrm>
            <a:off x="0" y="0"/>
            <a:ext cx="686149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 Gating </a:t>
            </a:r>
            <a:r>
              <a:rPr lang="en-US" altLang="zh-CN" sz="2000" b="1" dirty="0">
                <a:solidFill>
                  <a:prstClr val="black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S</a:t>
            </a:r>
            <a:r>
              <a:rPr kumimoji="0" lang="en-US" altLang="zh-CN" sz="2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trategy</a:t>
            </a: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 For BODIPY Lipid Peroxidation Assay 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4EBA7B0-B922-20BE-E5FC-0C5F33510C7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346" r="8049"/>
          <a:stretch/>
        </p:blipFill>
        <p:spPr>
          <a:xfrm>
            <a:off x="493295" y="816207"/>
            <a:ext cx="7086600" cy="55657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90045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6</TotalTime>
  <Words>36</Words>
  <Application>Microsoft Macintosh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dretti Silvia</dc:creator>
  <cp:lastModifiedBy>Pedretti Silvia</cp:lastModifiedBy>
  <cp:revision>1</cp:revision>
  <dcterms:created xsi:type="dcterms:W3CDTF">2025-05-15T10:54:08Z</dcterms:created>
  <dcterms:modified xsi:type="dcterms:W3CDTF">2025-05-19T11:44:44Z</dcterms:modified>
</cp:coreProperties>
</file>